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14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ECC16-999E-4753-96BC-164F6BAB6BFE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910A4-87BA-4042-AB84-E9F1B92B7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990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ECC16-999E-4753-96BC-164F6BAB6BFE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910A4-87BA-4042-AB84-E9F1B92B7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388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ECC16-999E-4753-96BC-164F6BAB6BFE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910A4-87BA-4042-AB84-E9F1B92B7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056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ECC16-999E-4753-96BC-164F6BAB6BFE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910A4-87BA-4042-AB84-E9F1B92B7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1361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ECC16-999E-4753-96BC-164F6BAB6BFE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910A4-87BA-4042-AB84-E9F1B92B7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626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ECC16-999E-4753-96BC-164F6BAB6BFE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910A4-87BA-4042-AB84-E9F1B92B7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103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ECC16-999E-4753-96BC-164F6BAB6BFE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910A4-87BA-4042-AB84-E9F1B92B7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3162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ECC16-999E-4753-96BC-164F6BAB6BFE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910A4-87BA-4042-AB84-E9F1B92B7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285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ECC16-999E-4753-96BC-164F6BAB6BFE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910A4-87BA-4042-AB84-E9F1B92B7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2165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ECC16-999E-4753-96BC-164F6BAB6BFE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910A4-87BA-4042-AB84-E9F1B92B7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545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5ECC16-999E-4753-96BC-164F6BAB6BFE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910A4-87BA-4042-AB84-E9F1B92B7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4096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5ECC16-999E-4753-96BC-164F6BAB6BFE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2910A4-87BA-4042-AB84-E9F1B92B72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074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55" b="2339"/>
          <a:stretch/>
        </p:blipFill>
        <p:spPr bwMode="auto">
          <a:xfrm>
            <a:off x="303573" y="990600"/>
            <a:ext cx="8412536" cy="46139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27018" y="5715000"/>
            <a:ext cx="851012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smtClean="0">
                <a:latin typeface="Arial" panose="020B0604020202020204" pitchFamily="34" charset="0"/>
                <a:cs typeface="Arial" panose="020B0604020202020204" pitchFamily="34" charset="0"/>
              </a:rPr>
              <a:t>SF4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of vitamin D regulatory system  during proliferation, post-proliferation, and differentiation of 143B human OS cells  either treated with vehicle (Ctrl) or 1 </a:t>
            </a:r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25(OH)</a:t>
            </a:r>
            <a:r>
              <a:rPr lang="en-US" sz="11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1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by RT-qPCR (A) and western blotting (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sterisk (*) and # indicat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tatistical significance of p ≤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.05 and </a:t>
            </a:r>
            <a:r>
              <a:rPr lang="en-US" sz="11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0.005 respectively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371600" y="363598"/>
            <a:ext cx="66600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emporal expression of Vitamin D Regulatory System in 143B osteosarcoma cell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5248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69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Veteran Affair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imella, Rama (KCVA)</dc:creator>
  <cp:lastModifiedBy>Garimella, Rama (KCVA)</cp:lastModifiedBy>
  <cp:revision>6</cp:revision>
  <dcterms:created xsi:type="dcterms:W3CDTF">2017-02-10T19:04:45Z</dcterms:created>
  <dcterms:modified xsi:type="dcterms:W3CDTF">2017-03-14T17:46:38Z</dcterms:modified>
</cp:coreProperties>
</file>